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440021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45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60" d="100"/>
          <a:sy n="60" d="100"/>
        </p:scale>
        <p:origin x="618" y="-198"/>
      </p:cViewPr>
      <p:guideLst>
        <p:guide orient="horz" pos="5670"/>
        <p:guide pos="45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945943"/>
            <a:ext cx="12240181" cy="626689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9454516"/>
            <a:ext cx="10800160" cy="4345992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846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0628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958369"/>
            <a:ext cx="3105046" cy="1525473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958369"/>
            <a:ext cx="9135135" cy="1525473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0812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024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4487671"/>
            <a:ext cx="12420184" cy="7487774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12046282"/>
            <a:ext cx="12420184" cy="3937644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9876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4791843"/>
            <a:ext cx="6120091" cy="114212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4791843"/>
            <a:ext cx="6120091" cy="114212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9998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58373"/>
            <a:ext cx="12420184" cy="347929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4412664"/>
            <a:ext cx="6091964" cy="2162578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6575242"/>
            <a:ext cx="6091964" cy="9671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4412664"/>
            <a:ext cx="6121966" cy="2162578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6575242"/>
            <a:ext cx="6121966" cy="9671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165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3897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144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200044"/>
            <a:ext cx="4644444" cy="420015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591766"/>
            <a:ext cx="7290108" cy="12792138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5400199"/>
            <a:ext cx="4644444" cy="10004536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671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200044"/>
            <a:ext cx="4644444" cy="420015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591766"/>
            <a:ext cx="7290108" cy="12792138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5400199"/>
            <a:ext cx="4644444" cy="10004536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947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958373"/>
            <a:ext cx="12420184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4791843"/>
            <a:ext cx="12420184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6683952"/>
            <a:ext cx="3240048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C11976-45FA-4ED5-B730-EF509EBF5F0D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6683952"/>
            <a:ext cx="4860072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6683952"/>
            <a:ext cx="3240048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68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kumimoji="1"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kumimoji="1"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AFC94E3-A052-45BA-AF2F-DB7B609168A6}"/>
              </a:ext>
            </a:extLst>
          </p:cNvPr>
          <p:cNvSpPr txBox="1"/>
          <p:nvPr/>
        </p:nvSpPr>
        <p:spPr>
          <a:xfrm>
            <a:off x="1447800" y="515035"/>
            <a:ext cx="72009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5 Table: Steel’s test results for young adults.</a:t>
            </a:r>
            <a:r>
              <a:rPr lang="ja-JP" altLang="ja-JP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5F1CFFE-DADF-432F-AD44-B52827E14850}"/>
              </a:ext>
            </a:extLst>
          </p:cNvPr>
          <p:cNvSpPr txBox="1"/>
          <p:nvPr/>
        </p:nvSpPr>
        <p:spPr>
          <a:xfrm>
            <a:off x="5947493" y="5544660"/>
            <a:ext cx="72029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11049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1; 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; †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.1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6" name="コンテンツ プレースホルダー 4">
            <a:extLst>
              <a:ext uri="{FF2B5EF4-FFF2-40B4-BE49-F238E27FC236}">
                <a16:creationId xmlns:a16="http://schemas.microsoft.com/office/drawing/2014/main" id="{5CE50EE2-1069-4016-B75D-3586CC0DE43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4019077"/>
              </p:ext>
            </p:extLst>
          </p:nvPr>
        </p:nvGraphicFramePr>
        <p:xfrm>
          <a:off x="1442320" y="1321885"/>
          <a:ext cx="11519998" cy="4045786"/>
        </p:xfrm>
        <a:graphic>
          <a:graphicData uri="http://schemas.openxmlformats.org/drawingml/2006/table">
            <a:tbl>
              <a:tblPr firstRow="1" bandRow="1"/>
              <a:tblGrid>
                <a:gridCol w="1674844">
                  <a:extLst>
                    <a:ext uri="{9D8B030D-6E8A-4147-A177-3AD203B41FA5}">
                      <a16:colId xmlns:a16="http://schemas.microsoft.com/office/drawing/2014/main" val="1515568235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3835691058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2921394414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3354734976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332734769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2316968394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3961046281"/>
                    </a:ext>
                  </a:extLst>
                </a:gridCol>
              </a:tblGrid>
              <a:tr h="424052">
                <a:tc rowSpan="2">
                  <a:txBody>
                    <a:bodyPr/>
                    <a:lstStyle>
                      <a:lvl1pPr marL="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ditions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497D">
                        <a:lumMod val="20000"/>
                        <a:lumOff val="80000"/>
                      </a:srgbClr>
                    </a:solidFill>
                  </a:tcPr>
                </a:tc>
                <a:tc gridSpan="3">
                  <a:txBody>
                    <a:bodyPr/>
                    <a:lstStyle>
                      <a:lvl1pPr marL="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m</a:t>
                      </a:r>
                      <a:r>
                        <a:rPr kumimoji="1" lang="el-GR" altLang="ja-JP" sz="18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θ</a:t>
                      </a:r>
                      <a:endParaRPr kumimoji="1" lang="en-US" altLang="ja-JP" sz="18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497D">
                        <a:lumMod val="20000"/>
                        <a:lumOff val="8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/>
                </a:tc>
                <a:tc gridSpan="3">
                  <a:txBody>
                    <a:bodyPr/>
                    <a:lstStyle>
                      <a:lvl1pPr marL="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</a:t>
                      </a:r>
                      <a:r>
                        <a:rPr kumimoji="1" lang="el-GR" altLang="ja-JP" sz="18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endParaRPr kumimoji="1" lang="en-US" altLang="ja-JP" sz="18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497D">
                        <a:lumMod val="20000"/>
                        <a:lumOff val="8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/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/>
                </a:tc>
                <a:extLst>
                  <a:ext uri="{0D108BD9-81ED-4DB2-BD59-A6C34878D82A}">
                    <a16:rowId xmlns:a16="http://schemas.microsoft.com/office/drawing/2014/main" val="1562353663"/>
                  </a:ext>
                </a:extLst>
              </a:tr>
              <a:tr h="42405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coding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381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rst retention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tter retention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coding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rst retention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tter retention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2844118"/>
                  </a:ext>
                </a:extLst>
              </a:tr>
              <a:tr h="532947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eutral-Cong.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4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73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ja-JP" sz="18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73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ja-JP" sz="18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2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483989"/>
                  </a:ext>
                </a:extLst>
              </a:tr>
              <a:tr h="532947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eutral-</a:t>
                      </a:r>
                      <a:r>
                        <a:rPr kumimoji="1" lang="en-US" altLang="ja-JP" sz="18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.001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4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4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ja-JP" sz="18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4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ja-JP" sz="18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95209"/>
                  </a:ext>
                </a:extLst>
              </a:tr>
              <a:tr h="532947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ngry-Cong.</a:t>
                      </a:r>
                      <a:endParaRPr kumimoji="1" lang="en-US" altLang="ja-JP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4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73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73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4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79013"/>
                  </a:ext>
                </a:extLst>
              </a:tr>
              <a:tr h="532947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ngry-</a:t>
                      </a:r>
                      <a:r>
                        <a:rPr kumimoji="1" lang="en-US" altLang="ja-JP" sz="18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2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4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ja-JP" sz="18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4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2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9922413"/>
                  </a:ext>
                </a:extLst>
              </a:tr>
              <a:tr h="532947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appy-Cong.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4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.001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.001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1847362"/>
                  </a:ext>
                </a:extLst>
              </a:tr>
              <a:tr h="532947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appy-</a:t>
                      </a:r>
                      <a:r>
                        <a:rPr kumimoji="1" lang="en-US" altLang="ja-JP" sz="18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2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.001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ja-JP" sz="18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4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4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ja-JP" sz="18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4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22902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95819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</TotalTime>
  <Words>151</Words>
  <Application>Microsoft Office PowerPoint</Application>
  <PresentationFormat>ユーザー設定</PresentationFormat>
  <Paragraphs>5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柏原 考爾(kojikasi)</dc:creator>
  <cp:lastModifiedBy>柏原 考爾(kojikasi)</cp:lastModifiedBy>
  <cp:revision>70</cp:revision>
  <dcterms:created xsi:type="dcterms:W3CDTF">2022-04-02T10:24:12Z</dcterms:created>
  <dcterms:modified xsi:type="dcterms:W3CDTF">2022-04-02T15:24:44Z</dcterms:modified>
</cp:coreProperties>
</file>